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D224D2-1A03-4C65-BB23-AE2A54FE26A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2AC497-7C22-4172-B2DB-8AB6043383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D1B0BE-8FE9-4F21-B208-3792EF3AD0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149AB-8B7A-4642-A6F9-B2D27EA138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239977-4468-4C21-9E93-438461D63F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52C57D-995A-4ADA-818A-C3D1D2AEFB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DA7BE8-5EA3-4964-A8D5-26A414239E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432DB9-4A14-4023-853D-CC988C12D7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34A616-6B36-46B7-8B7D-9678E913AE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77AE7B-B864-477D-A784-86409F9FC5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7BC535-D42A-4688-9649-C9659F2D84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4C7086-8FD4-448C-BDB3-FDEB952129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5E429D-F39A-456F-B995-3A66619A40D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6"/>
          <p:cNvSpPr/>
          <p:nvPr/>
        </p:nvSpPr>
        <p:spPr>
          <a:xfrm>
            <a:off x="380880" y="304920"/>
            <a:ext cx="8016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Rat: __________________          Date: ___________________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7"/>
          <p:cNvSpPr/>
          <p:nvPr/>
        </p:nvSpPr>
        <p:spPr>
          <a:xfrm>
            <a:off x="609480" y="5715000"/>
            <a:ext cx="251460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aximum Possible Score = 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8"/>
          <p:cNvSpPr/>
          <p:nvPr/>
        </p:nvSpPr>
        <p:spPr>
          <a:xfrm>
            <a:off x="6019920" y="5694480"/>
            <a:ext cx="290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verage: ________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4" name=""/>
          <p:cNvGraphicFramePr/>
          <p:nvPr/>
        </p:nvGraphicFramePr>
        <p:xfrm>
          <a:off x="457200" y="808200"/>
          <a:ext cx="7848720" cy="4706640"/>
        </p:xfrm>
        <a:graphic>
          <a:graphicData uri="http://schemas.openxmlformats.org/drawingml/2006/table">
            <a:tbl>
              <a:tblPr/>
              <a:tblGrid>
                <a:gridCol w="762120"/>
                <a:gridCol w="1143000"/>
                <a:gridCol w="1641240"/>
                <a:gridCol w="1863720"/>
                <a:gridCol w="1600200"/>
                <a:gridCol w="838440"/>
              </a:tblGrid>
              <a:tr h="668160">
                <a:tc rowSpan="5"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rops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intains Paw/Treat</a:t>
                      </a:r>
                      <a:br>
                        <a:rPr sz="1200"/>
                      </a:b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ff Ground While</a:t>
                      </a:r>
                      <a:br>
                        <a:rPr sz="1200"/>
                      </a:b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lding &amp; Eating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psilateral Paw Status During Treat Contact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psilateral</a:t>
                      </a:r>
                      <a:br>
                        <a:rPr sz="1200"/>
                      </a:b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eat Manipulation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349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ne = 1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lways = 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lmar = 3</a:t>
                      </a:r>
                      <a:br>
                        <a:rPr sz="1200"/>
                      </a:b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grasps treats with digits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Yes = 2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684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ny = 0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gt; 50%, &lt; 100% = 1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rsal/Palmar = 2</a:t>
                      </a:r>
                      <a:br>
                        <a:rPr sz="1200"/>
                      </a:b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props treat against</a:t>
                      </a:r>
                      <a:br>
                        <a:rPr sz="1200"/>
                      </a:b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rtially closed fist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= 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660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50% of the time = 0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rsal = 1 </a:t>
                      </a:r>
                      <a:br>
                        <a:rPr sz="1200"/>
                      </a:b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props treat against closed/clenched fist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638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contact = 0</a:t>
                      </a:r>
                      <a:br>
                        <a:rPr sz="1200"/>
                      </a:b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ipsilateral paw has</a:t>
                      </a:r>
                      <a:br>
                        <a:rPr sz="1200"/>
                      </a:b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contact with treat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0880"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ial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fbfbf"/>
                    </a:solidFill>
                  </a:tcPr>
                </a:tc>
              </a:tr>
              <a:tr h="378000"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0880"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0880"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13T12:56:48Z</dcterms:created>
  <dc:creator>CLW</dc:creator>
  <dc:description/>
  <dc:language>en-US</dc:language>
  <cp:lastModifiedBy>Chandler Walker</cp:lastModifiedBy>
  <dcterms:modified xsi:type="dcterms:W3CDTF">2011-09-12T01:17:37Z</dcterms:modified>
  <cp:revision>10</cp:revision>
  <dc:subject/>
  <dc:title>PowerPoint Presentation</dc:title>
</cp:coreProperties>
</file>